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</p:sldIdLst>
  <p:sldSz cx="6119813" cy="7559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981" autoAdjust="0"/>
    <p:restoredTop sz="94660"/>
  </p:normalViewPr>
  <p:slideViewPr>
    <p:cSldViewPr snapToGrid="0">
      <p:cViewPr varScale="1">
        <p:scale>
          <a:sx n="136" d="100"/>
          <a:sy n="136" d="100"/>
        </p:scale>
        <p:origin x="2946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237197"/>
            <a:ext cx="5201841" cy="2631887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3970580"/>
            <a:ext cx="4589860" cy="1825171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A3652-316C-4C93-9066-E96B246CDF7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2E0F2-422B-454E-BFDB-4B19D4BF85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8526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A3652-316C-4C93-9066-E96B246CDF7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2E0F2-422B-454E-BFDB-4B19D4BF85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77109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02483"/>
            <a:ext cx="1319585" cy="640647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02483"/>
            <a:ext cx="3882256" cy="640647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A3652-316C-4C93-9066-E96B246CDF7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2E0F2-422B-454E-BFDB-4B19D4BF85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56631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A3652-316C-4C93-9066-E96B246CDF7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2E0F2-422B-454E-BFDB-4B19D4BF85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2871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884671"/>
            <a:ext cx="5278339" cy="3144614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059035"/>
            <a:ext cx="5278339" cy="1653678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A3652-316C-4C93-9066-E96B246CDF7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2E0F2-422B-454E-BFDB-4B19D4BF85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2451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012414"/>
            <a:ext cx="2600921" cy="479654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012414"/>
            <a:ext cx="2600921" cy="479654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A3652-316C-4C93-9066-E96B246CDF7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2E0F2-422B-454E-BFDB-4B19D4BF85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72533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02484"/>
            <a:ext cx="5278339" cy="146118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853171"/>
            <a:ext cx="2588967" cy="908210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761381"/>
            <a:ext cx="2588967" cy="406157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853171"/>
            <a:ext cx="2601718" cy="908210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761381"/>
            <a:ext cx="2601718" cy="406157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A3652-316C-4C93-9066-E96B246CDF7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2E0F2-422B-454E-BFDB-4B19D4BF85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62540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A3652-316C-4C93-9066-E96B246CDF7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2E0F2-422B-454E-BFDB-4B19D4BF85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6398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A3652-316C-4C93-9066-E96B246CDF7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2E0F2-422B-454E-BFDB-4B19D4BF85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1002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03978"/>
            <a:ext cx="1973799" cy="1763924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088455"/>
            <a:ext cx="3098155" cy="5372269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267902"/>
            <a:ext cx="1973799" cy="420157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A3652-316C-4C93-9066-E96B246CDF7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2E0F2-422B-454E-BFDB-4B19D4BF85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65788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03978"/>
            <a:ext cx="1973799" cy="1763924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088455"/>
            <a:ext cx="3098155" cy="5372269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267902"/>
            <a:ext cx="1973799" cy="420157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A3652-316C-4C93-9066-E96B246CDF7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2E0F2-422B-454E-BFDB-4B19D4BF85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43140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02484"/>
            <a:ext cx="5278339" cy="1461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012414"/>
            <a:ext cx="5278339" cy="4796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006700"/>
            <a:ext cx="1376958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A3652-316C-4C93-9066-E96B246CDF72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006700"/>
            <a:ext cx="2065437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006700"/>
            <a:ext cx="1376958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72E0F2-422B-454E-BFDB-4B19D4BF85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98903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7164EAC7-230A-4C17-8903-61428FA74D36}"/>
              </a:ext>
            </a:extLst>
          </p:cNvPr>
          <p:cNvSpPr txBox="1"/>
          <p:nvPr/>
        </p:nvSpPr>
        <p:spPr>
          <a:xfrm>
            <a:off x="185846" y="882663"/>
            <a:ext cx="5502636" cy="40626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  <a:spcAft>
                <a:spcPts val="1200"/>
              </a:spcAft>
            </a:pPr>
            <a:r>
              <a:rPr lang="en-US" altLang="zh-CN" sz="1200" b="1" dirty="0">
                <a:solidFill>
                  <a:srgbClr val="0E101A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igh-performance liquid chromatography-mass spectrometry (HPLC-MS) assay and luciferase assays for evaluating the endogenous estrogenic effects in prostate cancer cells</a:t>
            </a:r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200" dirty="0">
                <a:solidFill>
                  <a:srgbClr val="0E101A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7β-estradiol concentration in PC3 cells was determined by HPLC-MS. Cells were dissociated into single cells, and 106 cells resuspended in PBS. The samples were prepared as previously described[1]. Liquid chromatography-tandem mass spectrometry (LCMS-2020, SHIMADZU, Japan) was used to measure the concentration of 17-β-estradiol. The 17β-estradiol detected by mass spectrometry is 506m/z, and the retention time is 6.1 minutes (Fig. S1). </a:t>
            </a:r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200" dirty="0">
                <a:solidFill>
                  <a:srgbClr val="0E101A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 Estrogen receptor activity was determined by luciferase assays. pGL3-(ERE)6-luciferase receptor plasmids and </a:t>
            </a:r>
            <a:r>
              <a:rPr lang="en-US" altLang="zh-CN" sz="1200" dirty="0" err="1">
                <a:solidFill>
                  <a:srgbClr val="0E101A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TK</a:t>
            </a:r>
            <a:r>
              <a:rPr lang="en-US" altLang="zh-CN" sz="1200" dirty="0">
                <a:solidFill>
                  <a:srgbClr val="0E101A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RL were co-transfected into PC3 cells after indicated treatment, and used the Dual-Luciferase Assay Kit (Promega, USA) to evaluate the luciferase activity, as described above. </a:t>
            </a:r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 </a:t>
            </a:r>
            <a:endParaRPr lang="zh-CN" altLang="zh-CN" sz="12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Bef>
                <a:spcPts val="1200"/>
              </a:spcBef>
              <a:spcAft>
                <a:spcPts val="1200"/>
              </a:spcAft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ferences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180975" indent="-180975" algn="just"/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[1] Huang HJ, Chiang PH, and Chen SH. Quantitative analysis of estrogens and estrogen metabolites in endogenous MCF-7 breast cancer cells by liquid chromatography-tandem mass spectrometry. J </a:t>
            </a:r>
            <a:r>
              <a:rPr lang="en-US" altLang="zh-CN" sz="12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hromatogr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B </a:t>
            </a:r>
            <a:r>
              <a:rPr lang="en-US" altLang="zh-CN" sz="12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alyt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echnol Biomed Life Sci (2011) 879: 1748-56. doi:10.1016/j.jchromb.2011.04.020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 </a:t>
            </a:r>
            <a:endParaRPr lang="zh-CN" altLang="zh-CN" sz="12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78D820C-9CD2-44E3-9FBA-601446D3C96F}"/>
              </a:ext>
            </a:extLst>
          </p:cNvPr>
          <p:cNvSpPr txBox="1"/>
          <p:nvPr/>
        </p:nvSpPr>
        <p:spPr>
          <a:xfrm>
            <a:off x="190500" y="322223"/>
            <a:ext cx="274666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method</a:t>
            </a:r>
            <a:r>
              <a:rPr lang="en-US" altLang="zh-CN" sz="16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 </a:t>
            </a:r>
            <a:endParaRPr lang="zh-CN" altLang="zh-CN" sz="1600" b="1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79070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207</Words>
  <Application>Microsoft Office PowerPoint</Application>
  <PresentationFormat>自定义</PresentationFormat>
  <Paragraphs>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林 启妹</dc:creator>
  <cp:lastModifiedBy>林 启妹</cp:lastModifiedBy>
  <cp:revision>4</cp:revision>
  <dcterms:created xsi:type="dcterms:W3CDTF">2021-09-30T14:13:15Z</dcterms:created>
  <dcterms:modified xsi:type="dcterms:W3CDTF">2021-10-01T08:54:31Z</dcterms:modified>
</cp:coreProperties>
</file>